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330900" y="4585400"/>
            <a:ext cx="8482200" cy="558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Supplementary Figure 4: Gene recall curve of identified biomarkers concerning reference biomarker of each cell identified by scaLR in top 5,000 features of PBMC-SLE dataset.</a:t>
            </a:r>
            <a:r>
              <a:rPr b="1" lang="en" sz="1200">
                <a:solidFill>
                  <a:schemeClr val="dk2"/>
                </a:solidFill>
              </a:rPr>
              <a:t> </a:t>
            </a:r>
            <a:r>
              <a:rPr b="1" lang="en" sz="1200">
                <a:solidFill>
                  <a:schemeClr val="dk2"/>
                </a:solidFill>
              </a:rPr>
              <a:t> 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55" name="Google Shape;55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24650" y="0"/>
            <a:ext cx="7638451" cy="458382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